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B5814E-5E57-4ECB-89FC-0E1A1B3511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833592-12E7-42E1-9C9C-56BB679ABF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22C0BD-DD40-4A06-BCBE-8229D5B87C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4C1EEC-B5B9-4EEB-9984-A53C99BC90C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7E582A-7F5F-45E2-8AF0-7146127F3A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A79DD8-5318-44FE-B1CD-3901355444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19E464-9A51-49C8-810F-974FAFD714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82F73E-D596-42DC-8566-778BE3BE39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712BE1-464B-44B6-B032-9DD0B3433E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0F90C6-06F3-4C38-9353-56301C543A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0E4C66-78AA-4798-8273-BAD0691AE0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B01D2D-577A-41BC-84FF-93319ECA4D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E0BC4A-8ED2-4BC2-A16C-A86140219EDA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rcRect l="0" t="0" r="0" b="32590"/>
          <a:stretch/>
        </p:blipFill>
        <p:spPr>
          <a:xfrm>
            <a:off x="514440" y="652320"/>
            <a:ext cx="2736720" cy="16257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"/>
          <p:cNvPicPr/>
          <p:nvPr/>
        </p:nvPicPr>
        <p:blipFill>
          <a:blip r:embed="rId2"/>
          <a:srcRect l="0" t="0" r="0" b="32593"/>
          <a:stretch/>
        </p:blipFill>
        <p:spPr>
          <a:xfrm>
            <a:off x="514440" y="668160"/>
            <a:ext cx="1758960" cy="115272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43" name=""/>
          <p:cNvGraphicFramePr/>
          <p:nvPr/>
        </p:nvGraphicFramePr>
        <p:xfrm>
          <a:off x="495360" y="104760"/>
          <a:ext cx="6191280" cy="480960"/>
        </p:xfrm>
        <a:graphic>
          <a:graphicData uri="http://schemas.openxmlformats.org/drawingml/2006/table">
            <a:tbl>
              <a:tblPr/>
              <a:tblGrid>
                <a:gridCol w="1276200"/>
                <a:gridCol w="1657440"/>
                <a:gridCol w="1655640"/>
                <a:gridCol w="792360"/>
                <a:gridCol w="809640"/>
              </a:tblGrid>
              <a:tr h="219240"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System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rimer forwar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rimer rever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Expected T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Expected siz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261720"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60400302-HERV0489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GGGATACTGCACTCATTCAT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AGGGTCTCAAAAGGAATCAT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0.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7 p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</a:tr>
            </a:tbl>
          </a:graphicData>
        </a:graphic>
      </p:graphicFrame>
      <p:sp>
        <p:nvSpPr>
          <p:cNvPr id="44" name="ZoneTexte 17"/>
          <p:cNvSpPr/>
          <p:nvPr/>
        </p:nvSpPr>
        <p:spPr>
          <a:xfrm>
            <a:off x="6232680" y="2106720"/>
            <a:ext cx="6523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34 p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ectangle 7"/>
          <p:cNvSpPr/>
          <p:nvPr/>
        </p:nvSpPr>
        <p:spPr>
          <a:xfrm>
            <a:off x="522360" y="685800"/>
            <a:ext cx="720720" cy="291960"/>
          </a:xfrm>
          <a:prstGeom prst="rect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ffffff"/>
                </a:solidFill>
                <a:latin typeface="Calibri"/>
              </a:rPr>
              <a:t>56°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ffffff"/>
                </a:solidFill>
                <a:latin typeface="Calibri"/>
              </a:rPr>
              <a:t>gDNA: 1 ng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Rectangle 8"/>
          <p:cNvSpPr/>
          <p:nvPr/>
        </p:nvSpPr>
        <p:spPr>
          <a:xfrm>
            <a:off x="163440" y="57240"/>
            <a:ext cx="6573960" cy="87627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ZoneTexte 5"/>
          <p:cNvSpPr/>
          <p:nvPr/>
        </p:nvSpPr>
        <p:spPr>
          <a:xfrm>
            <a:off x="182520" y="66600"/>
            <a:ext cx="324000" cy="31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ZoneTexte 5"/>
          <p:cNvSpPr/>
          <p:nvPr/>
        </p:nvSpPr>
        <p:spPr>
          <a:xfrm>
            <a:off x="169920" y="668160"/>
            <a:ext cx="323640" cy="31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ZoneTexte 5"/>
          <p:cNvSpPr/>
          <p:nvPr/>
        </p:nvSpPr>
        <p:spPr>
          <a:xfrm>
            <a:off x="4597560" y="614520"/>
            <a:ext cx="323640" cy="31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ZoneTexte 5"/>
          <p:cNvSpPr/>
          <p:nvPr/>
        </p:nvSpPr>
        <p:spPr>
          <a:xfrm>
            <a:off x="165240" y="2382840"/>
            <a:ext cx="323640" cy="31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1" name="Connecteur droit avec flèche 13"/>
          <p:cNvCxnSpPr/>
          <p:nvPr/>
        </p:nvCxnSpPr>
        <p:spPr>
          <a:xfrm flipH="1">
            <a:off x="5935320" y="2236320"/>
            <a:ext cx="32904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52" name="ZoneTexte 5"/>
          <p:cNvSpPr/>
          <p:nvPr/>
        </p:nvSpPr>
        <p:spPr>
          <a:xfrm>
            <a:off x="87480" y="3987720"/>
            <a:ext cx="323640" cy="31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3" name=""/>
          <p:cNvGraphicFramePr/>
          <p:nvPr/>
        </p:nvGraphicFramePr>
        <p:xfrm>
          <a:off x="339840" y="4041720"/>
          <a:ext cx="6343560" cy="4687920"/>
        </p:xfrm>
        <a:graphic>
          <a:graphicData uri="http://schemas.openxmlformats.org/drawingml/2006/table">
            <a:tbl>
              <a:tblPr/>
              <a:tblGrid>
                <a:gridCol w="1500120"/>
                <a:gridCol w="1779480"/>
                <a:gridCol w="1565280"/>
                <a:gridCol w="711360"/>
                <a:gridCol w="787320"/>
              </a:tblGrid>
              <a:tr h="247680">
                <a:tc>
                  <a:txBody>
                    <a:bodyPr lIns="3600" rIns="3600" tIns="3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b0f0"/>
                          </a:solidFill>
                          <a:latin typeface="Calibri"/>
                        </a:rPr>
                        <a:t>Name of probesets 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b0f0"/>
                          </a:solidFill>
                          <a:latin typeface="Calibri"/>
                        </a:rPr>
                        <a:t>Primer Forward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b0f0"/>
                          </a:solidFill>
                          <a:latin typeface="Calibri"/>
                        </a:rPr>
                        <a:t>Primer Rever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b0f0"/>
                          </a:solidFill>
                          <a:latin typeface="Calibri"/>
                        </a:rPr>
                        <a:t>Tm experiment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b0f0"/>
                          </a:solidFill>
                          <a:latin typeface="Calibri"/>
                        </a:rPr>
                        <a:t>Length amplicon experimental (pb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21460102-HERV0599uL_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CACAGAAAGGGACCCT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CACAGCTTGAGAATGTGGTA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42486301-MALR1015uL_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AAAGCGAGGACTTAATGG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CAAGCTATCTGAACCCCAT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9400"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50286002-MALR1003uL_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ACATTTAGGGCCTAGCC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GAAGATATCCACAGCCGA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9,3/59,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50286701-HERV0513uL_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GGTGGCTGCATCCTAT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GGTCAGGAAAAAATTTGCCT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50287402-MALR1022uL_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ATGACATTGTCTGAACTTTG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AGGACCATGCAGATACTAGTG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50734202-MALR1019uL_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CTTCTGCCCACCTCACT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TGGGTTTAAATCCAGTCCG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94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61827101-HERV0856uL_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TGTGCTTGATGTGCC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CATGCTTGCTCATTCACA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71588201-MALR1023uL_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GCTTGTTGCTCTCTGAACATT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CAGGCTGACCTCCAAA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81921101-HERV0958uI_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AGTTGAACCCAAGGGTATC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ACCCATCATTGCTAGCAG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81921102-HERV0958uI_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CACTCCTGTGGAATTAGTTCTT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AAAGGATTATGCTAGGTGCTGTTG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904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81921103-HERV0958uI_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GTAGATGGGGCAAGTTGAAGT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AGCAACAGCCTGAGGCTA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96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223002-HERV0378uL_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CTCTTTCCCCATCACTACCA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AAGTAGTCACAGCTTCTGG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0076702-HERV0489uL_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TGCTGGTACTTCCCTGT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TGTCCCAGATACACTCTCCA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0093401-HERV1034uL_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AAGGAATTGGCTCATGG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TAGACAGCAGCTTCAGCAG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1467702-HERV0490uL_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GAGTGCTTCTATTTGGGAGAG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CATCGTTCATTCTACCCTCCT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904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0037501-MALR1023uL_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GGCTATGGGATCCAGTTCT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CCCAGTGACAGTTTTTCCC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0360601-HERV0808cL_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CTGTACTGGTTGCCCCA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GTGCCAGGCCTCTAATACTTT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96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0894002-HERV0421uL_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ATGCTTCTGTGGCCA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GGCATCCCATTCCCATTT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1107102-MALR1019uL_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GGAAGACCCCAAGATGA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TGCAAAGTCCAACGAGA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904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1115102-HERV0608uL_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ATAGACTCACCCGTAGC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TAAAGCAGGAGCCAATGC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0627301-MALR1014uL_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CCTACATAACAAACAGCCC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GCAGCTGAGATCCGTT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0369402HE41env_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GGCTCATAGGGATTCCAGA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CAAGTTGTCAAGAGCCAAT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96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0828901-HERV0770cL_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CTGAGCGTTTTTATGCTGG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TACACAGGTCTTGCCGAGA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904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0148802-MALR1127uL_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ACTGGTTTTGAACTCCTAGGCT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CCCCTCCCAAATGCATATGT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0478501-MALR1003cL_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ATGTTGGTTTGTGTCTTG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GCGTGCAGTGGTGT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0246901-HERV0889uL_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AATGAACACCTGGGCAAAC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GCCTAACGTAAGCACCCA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0247002-HERV0797uL_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CAGAGAGGCATAATGAAG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ATTCTAAGCCTCCCCCTCATT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94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32622601MR41sLU5p_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GCAGGAAAGGGGTGC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ACTCTATGGACTCGCCCT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468701-MALR0820cL_s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TAAAGGAATACCTGAGGCTG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CTGAGCTCGGCCTCT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pic>
        <p:nvPicPr>
          <p:cNvPr id="54" name="Picture 26" descr=""/>
          <p:cNvPicPr/>
          <p:nvPr/>
        </p:nvPicPr>
        <p:blipFill>
          <a:blip r:embed="rId3"/>
          <a:stretch/>
        </p:blipFill>
        <p:spPr>
          <a:xfrm>
            <a:off x="506520" y="2382840"/>
            <a:ext cx="4395600" cy="1604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5" name="Picture 194" descr=""/>
          <p:cNvPicPr/>
          <p:nvPr/>
        </p:nvPicPr>
        <p:blipFill>
          <a:blip r:embed="rId4"/>
          <a:stretch/>
        </p:blipFill>
        <p:spPr>
          <a:xfrm>
            <a:off x="5018040" y="611280"/>
            <a:ext cx="865080" cy="2232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6-17T13:21:19Z</dcterms:created>
  <dc:creator>MOMMERT Marine</dc:creator>
  <dc:description/>
  <dc:language>en-US</dc:language>
  <cp:lastModifiedBy>MOMMERT Marine</cp:lastModifiedBy>
  <dcterms:modified xsi:type="dcterms:W3CDTF">2019-10-02T14:57:30Z</dcterms:modified>
  <cp:revision>1</cp:revision>
  <dc:subject/>
  <dc:title>Présentation PowerPoint</dc:title>
</cp:coreProperties>
</file>